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>
        <p:scale>
          <a:sx n="70" d="100"/>
          <a:sy n="70" d="100"/>
        </p:scale>
        <p:origin x="-1386" y="-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8347F-13E7-4916-A825-6A2E27045B33}" type="datetimeFigureOut">
              <a:rPr lang="en-US" smtClean="0"/>
              <a:pPr/>
              <a:t>6/9/201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386B3-B2CE-46E7-96E9-BE9C8A7DA853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6"/>
          <p:cNvSpPr>
            <a:spLocks noChangeArrowheads="1"/>
          </p:cNvSpPr>
          <p:nvPr/>
        </p:nvSpPr>
        <p:spPr bwMode="auto">
          <a:xfrm>
            <a:off x="0" y="0"/>
            <a:ext cx="117532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2813">
              <a:buClr>
                <a:schemeClr val="accent2"/>
              </a:buClr>
              <a:buSzPct val="85000"/>
            </a:pPr>
            <a:r>
              <a:rPr lang="en-US" sz="1600" b="1" dirty="0" smtClean="0">
                <a:latin typeface="Verdana" pitchFamily="34" charset="0"/>
              </a:rPr>
              <a:t>Table S1</a:t>
            </a:r>
            <a:endParaRPr lang="en-US" sz="1600" b="1" dirty="0">
              <a:latin typeface="Verdana" pitchFamily="34" charset="0"/>
              <a:sym typeface="Symbol" pitchFamily="18" charset="2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533400" y="1371600"/>
          <a:ext cx="7543800" cy="4419837"/>
        </p:xfrm>
        <a:graphic>
          <a:graphicData uri="http://schemas.openxmlformats.org/drawingml/2006/table">
            <a:tbl>
              <a:tblPr/>
              <a:tblGrid>
                <a:gridCol w="1045028"/>
                <a:gridCol w="1045028"/>
                <a:gridCol w="1159329"/>
                <a:gridCol w="1045028"/>
                <a:gridCol w="3249387"/>
              </a:tblGrid>
              <a:tr h="347206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a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atrix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iomark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D Mode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rameter Estimates (CV 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6929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umo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S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=210.83(24.64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C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=251.49 ng/g (82.63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K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 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  = 489.58 (19.95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C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= 1444.22 ng/g (162.80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4EBP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   = 527.88 (18.25%)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C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=3733.43 ng/g(313.53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lasm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S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 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  = 195.98 (22.06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C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= 85.43 ng/mL (87.27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AK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   = 453.26 (14.36%)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C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= 1570.49 ng/mL (344.51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4EBP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</a:t>
                      </a:r>
                      <a:r>
                        <a:rPr lang="en-IN" sz="1600" b="0" i="0" u="none" strike="noStrike" baseline="-2500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r>
                        <a:rPr lang="en-IN" sz="16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   = 521.63 (15.91%)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7206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6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C</a:t>
                      </a:r>
                      <a:r>
                        <a:rPr lang="en-IN" sz="1600" b="0" i="0" u="none" strike="noStrike" baseline="-25000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r>
                        <a:rPr lang="en-IN" sz="16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= 1583.82 </a:t>
                      </a:r>
                      <a:r>
                        <a:rPr lang="en-IN" sz="16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g</a:t>
                      </a:r>
                      <a:r>
                        <a:rPr lang="en-IN" sz="16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/</a:t>
                      </a:r>
                      <a:r>
                        <a:rPr lang="en-IN" sz="1600" b="0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L</a:t>
                      </a:r>
                      <a:r>
                        <a:rPr lang="en-IN" sz="16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(316.50%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97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720167</dc:creator>
  <cp:lastModifiedBy>720167</cp:lastModifiedBy>
  <cp:revision>9</cp:revision>
  <dcterms:created xsi:type="dcterms:W3CDTF">2014-02-05T06:30:20Z</dcterms:created>
  <dcterms:modified xsi:type="dcterms:W3CDTF">2014-06-09T08:19:39Z</dcterms:modified>
</cp:coreProperties>
</file>